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2394" y="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4/12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193246" y="4468934"/>
            <a:ext cx="2566988" cy="138246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309636" y="4051248"/>
            <a:ext cx="1678904" cy="221605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3600" dirty="0"/>
              <a:t>Phenotype-based Management of Coronary Microvascular Dysfunction</a:t>
            </a:r>
            <a:endParaRPr lang="en-US" altLang="en-US" sz="72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762000" y="2514599"/>
            <a:ext cx="7315200" cy="1384251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2400" dirty="0"/>
              <a:t>Daniel TY Ang</a:t>
            </a:r>
            <a:r>
              <a:rPr lang="en-US" altLang="en-US" sz="2400" baseline="30000" dirty="0"/>
              <a:t>1</a:t>
            </a:r>
            <a:r>
              <a:rPr lang="en-US" altLang="en-US" sz="2400" dirty="0"/>
              <a:t>, Colin Berry</a:t>
            </a:r>
            <a:r>
              <a:rPr lang="en-US" altLang="en-US" sz="2400" baseline="30000" dirty="0"/>
              <a:t>1</a:t>
            </a:r>
            <a:r>
              <a:rPr lang="en-US" altLang="en-US" sz="2400" dirty="0"/>
              <a:t>, Juan-Carlos Kaski</a:t>
            </a:r>
            <a:r>
              <a:rPr lang="en-US" altLang="en-US" sz="2400" baseline="30000" dirty="0"/>
              <a:t>2</a:t>
            </a:r>
          </a:p>
          <a:p>
            <a:pPr marL="0" lvl="1"/>
            <a:r>
              <a:rPr lang="en-GB" altLang="en-US" sz="1400" baseline="30000" dirty="0"/>
              <a:t>1</a:t>
            </a:r>
            <a:r>
              <a:rPr lang="en-GB" altLang="en-US" sz="1400" dirty="0"/>
              <a:t>British Heart Foundation Glasgow Cardiovascular Research Centre, University of Glasgow, Glasgow, United Kingdom.</a:t>
            </a:r>
          </a:p>
          <a:p>
            <a:pPr marL="0" lvl="1"/>
            <a:r>
              <a:rPr lang="en-GB" altLang="en-US" sz="1400" baseline="30000" dirty="0"/>
              <a:t>2</a:t>
            </a:r>
            <a:r>
              <a:rPr lang="en-GB" altLang="en-US" sz="1400" dirty="0"/>
              <a:t>Molecular and Clinical Sciences Research Institute, St George’s University of London, London, United Kingdom.</a:t>
            </a:r>
            <a:endParaRPr lang="en-US" altLang="en-US" sz="14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A person smiling for the camera&#10;&#10;Description automatically generated with medium confidence">
            <a:extLst>
              <a:ext uri="{FF2B5EF4-FFF2-40B4-BE49-F238E27FC236}">
                <a16:creationId xmlns:a16="http://schemas.microsoft.com/office/drawing/2014/main" id="{0B9E13E2-AD8A-47E6-A9E5-DB4A842C171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4313" y="4051248"/>
            <a:ext cx="1678904" cy="2216052"/>
          </a:xfrm>
          <a:prstGeom prst="rect">
            <a:avLst/>
          </a:prstGeom>
        </p:spPr>
      </p:pic>
      <p:pic>
        <p:nvPicPr>
          <p:cNvPr id="8" name="Picture 7" descr="Text, logo&#10;&#10;Description automatically generated">
            <a:extLst>
              <a:ext uri="{FF2B5EF4-FFF2-40B4-BE49-F238E27FC236}">
                <a16:creationId xmlns:a16="http://schemas.microsoft.com/office/drawing/2014/main" id="{512B65B6-99CB-40C9-856D-0C3FB893959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0427" y="4467147"/>
            <a:ext cx="2566988" cy="1384251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481137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spcAft>
                <a:spcPts val="1200"/>
              </a:spcAft>
              <a:buNone/>
            </a:pPr>
            <a:r>
              <a:rPr lang="en-US" altLang="en-US" sz="2200" dirty="0"/>
              <a:t>1- 40-70% of patients undergoing invasive coronary angiography with signs and symptoms of ischemia have no obstructive coronary artery disease (INOCA).</a:t>
            </a:r>
          </a:p>
          <a:p>
            <a:pPr marL="0" indent="0">
              <a:spcAft>
                <a:spcPts val="1200"/>
              </a:spcAft>
              <a:buNone/>
            </a:pPr>
            <a:r>
              <a:rPr lang="en-US" altLang="en-US" sz="2200" dirty="0"/>
              <a:t>2- Of these, ~2/3 have coronary microvascular dysfunction.</a:t>
            </a:r>
          </a:p>
          <a:p>
            <a:pPr marL="0" indent="0">
              <a:spcAft>
                <a:spcPts val="1200"/>
              </a:spcAft>
              <a:buNone/>
            </a:pPr>
            <a:r>
              <a:rPr lang="en-US" altLang="en-US" sz="2200" dirty="0"/>
              <a:t>3- Patients with INOCA are a heterogeneous group with varying pathophysiological mechanisms.</a:t>
            </a:r>
          </a:p>
          <a:p>
            <a:pPr marL="0" indent="0">
              <a:spcAft>
                <a:spcPts val="1200"/>
              </a:spcAft>
              <a:buNone/>
            </a:pPr>
            <a:r>
              <a:rPr lang="en-US" altLang="en-US" sz="2200" dirty="0"/>
              <a:t>4- The main INOCA endotypes are: microvascular angina, vasospastic angina, mixed (microvascular and vasospastic), and non-cardiac symptoms (reclassification of diagnosis).</a:t>
            </a:r>
          </a:p>
          <a:p>
            <a:pPr marL="0" indent="0">
              <a:spcAft>
                <a:spcPts val="1200"/>
              </a:spcAft>
              <a:buNone/>
            </a:pPr>
            <a:r>
              <a:rPr lang="en-US" altLang="en-US" sz="2200" dirty="0"/>
              <a:t>5- Each condition may present with distinct symptoms and varied response to different treatments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Approach to Managing INOCA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44528" y="1524000"/>
            <a:ext cx="8570872" cy="4739738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200" dirty="0"/>
              <a:t>Accurate discrimination between INOCA endotypes is vital. Testing can be done during invasive angiography:</a:t>
            </a:r>
          </a:p>
          <a:p>
            <a:pPr marL="0" indent="0">
              <a:buNone/>
            </a:pP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0880" y="6282853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76080" y="6344354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F9F3FB5-BF47-4264-8C41-0F1FF2D805F2}"/>
              </a:ext>
            </a:extLst>
          </p:cNvPr>
          <p:cNvSpPr txBox="1"/>
          <p:nvPr/>
        </p:nvSpPr>
        <p:spPr>
          <a:xfrm>
            <a:off x="6341912" y="2595233"/>
            <a:ext cx="2489840" cy="3570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. 1:</a:t>
            </a:r>
            <a:r>
              <a:rPr lang="en-US" sz="1200" dirty="0"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 Stratified medical therapy guided by the interventional diagnostic procedure (IDP) in patients with INOCA. CAD – coronary artery disease, FFR – fractional flow reserve, CFR – coronary flow reserve, IMR – index of microvascular resistance, </a:t>
            </a:r>
            <a:r>
              <a:rPr lang="en-US" sz="1200" dirty="0" err="1"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ACh</a:t>
            </a:r>
            <a:r>
              <a:rPr lang="en-US" sz="1200" dirty="0"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 – acetylcholine, GTN – glyceryl trinitrate, Rx – therapy. </a:t>
            </a:r>
            <a:r>
              <a:rPr lang="en-GB" sz="800" i="1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Reprinted from the Journal of the American College of Cardiology, Vol 72(23 Pt A), Ford TJ, Stanley B, Good R, </a:t>
            </a:r>
            <a:r>
              <a:rPr lang="en-GB" sz="800" i="1" dirty="0" err="1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Rocchiccioli</a:t>
            </a:r>
            <a:r>
              <a:rPr lang="en-GB" sz="800" i="1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 P, McEntegart M, Watkins S, </a:t>
            </a:r>
            <a:r>
              <a:rPr lang="en-GB" sz="800" i="1" dirty="0" err="1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Eteiba</a:t>
            </a:r>
            <a:r>
              <a:rPr lang="en-GB" sz="800" i="1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 H, Shaukat A, Lindsay M, Robertson K, Hood S, </a:t>
            </a:r>
            <a:r>
              <a:rPr lang="en-GB" sz="800" i="1" dirty="0" err="1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McGeoch</a:t>
            </a:r>
            <a:r>
              <a:rPr lang="en-GB" sz="800" i="1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 R, McDade R, </a:t>
            </a:r>
            <a:r>
              <a:rPr lang="en-GB" sz="800" i="1" dirty="0" err="1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Yii</a:t>
            </a:r>
            <a:r>
              <a:rPr lang="en-GB" sz="800" i="1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 E, </a:t>
            </a:r>
            <a:r>
              <a:rPr lang="en-GB" sz="800" i="1" dirty="0" err="1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Sidik</a:t>
            </a:r>
            <a:r>
              <a:rPr lang="en-GB" sz="800" i="1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 N, McCartney P, Corcoran D, Collison D, Rush C, </a:t>
            </a:r>
            <a:r>
              <a:rPr lang="en-GB" sz="800" i="1" dirty="0" err="1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McConnachie</a:t>
            </a:r>
            <a:r>
              <a:rPr lang="en-GB" sz="800" i="1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 A, </a:t>
            </a:r>
            <a:r>
              <a:rPr lang="en-GB" sz="800" i="1" dirty="0" err="1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Touyz</a:t>
            </a:r>
            <a:r>
              <a:rPr lang="en-GB" sz="800" i="1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 RM, </a:t>
            </a:r>
            <a:r>
              <a:rPr lang="en-GB" sz="800" i="1" dirty="0" err="1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Oldroyd</a:t>
            </a:r>
            <a:r>
              <a:rPr lang="en-GB" sz="800" i="1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 KG, Berry C. Stratified Medical Therapy Using Invasive Coronary Function Testing in Angina: The CorMicA Trial, Page 2843, Copyright (2018), with permission from Elsevier.</a:t>
            </a:r>
            <a:endParaRPr lang="en-GB" sz="800" dirty="0">
              <a:effectLst/>
              <a:latin typeface="Georgia" panose="02040502050405020303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GB" dirty="0"/>
          </a:p>
        </p:txBody>
      </p:sp>
      <p:pic>
        <p:nvPicPr>
          <p:cNvPr id="6" name="Picture 5" descr="Graphical user interface, website&#10;&#10;Description automatically generated">
            <a:extLst>
              <a:ext uri="{FF2B5EF4-FFF2-40B4-BE49-F238E27FC236}">
                <a16:creationId xmlns:a16="http://schemas.microsoft.com/office/drawing/2014/main" id="{8CAF3205-EB24-44A0-8F5E-D721C0D1C30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000" y="2346410"/>
            <a:ext cx="5806440" cy="3867912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General Management Considerat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18848"/>
            <a:ext cx="8305800" cy="4500952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>
                <a:solidFill>
                  <a:srgbClr val="000000"/>
                </a:solidFill>
              </a:rPr>
              <a:t>1-</a:t>
            </a:r>
            <a:r>
              <a:rPr lang="en-US" altLang="en-US" sz="2400" dirty="0"/>
              <a:t>The goals of therapy are: 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/>
              <a:t>Improvement of outcomes by reducing MACE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/>
              <a:t>Improvement of symptoms and quality of life</a:t>
            </a:r>
          </a:p>
          <a:p>
            <a:pPr marL="0" indent="0">
              <a:buNone/>
            </a:pPr>
            <a:r>
              <a:rPr lang="en-US" altLang="en-US" sz="2400" dirty="0"/>
              <a:t>2- Cardiovascular risk factor control includes: 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/>
              <a:t>Antiplatelets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/>
              <a:t>Lipid lowering therapy (especially statins)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/>
              <a:t>Inhibition of the renin-angiotensin-aldosterone system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/>
              <a:t>Smoking cessation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/>
              <a:t>Achieving blood pressure and glycemic targets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/>
              <a:t>Healthy diet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/>
              <a:t>Exercise training (including cardiac rehabilitation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5899" y="6263738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2881" y="6329475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Phenotype-specific Angina Therapy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200" dirty="0">
                <a:solidFill>
                  <a:srgbClr val="000000"/>
                </a:solidFill>
              </a:rPr>
              <a:t>The choice of antianginal should be patient-centered, chosen according to the underlying pathophysiological mechanism, co-morbidities and preferences:</a:t>
            </a:r>
          </a:p>
          <a:p>
            <a:pPr marL="0" indent="0">
              <a:buNone/>
            </a:pPr>
            <a:endParaRPr lang="en-US" altLang="en-US" sz="24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A2E59ED-1BB6-4BCD-96CD-4AED746BFD66}"/>
              </a:ext>
            </a:extLst>
          </p:cNvPr>
          <p:cNvSpPr txBox="1"/>
          <p:nvPr/>
        </p:nvSpPr>
        <p:spPr>
          <a:xfrm>
            <a:off x="6525944" y="3352800"/>
            <a:ext cx="2035712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. 3:</a:t>
            </a:r>
            <a:r>
              <a:rPr lang="en-US" sz="1200" dirty="0"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 Management of angina according to the underlying disease mechanisms. </a:t>
            </a:r>
          </a:p>
          <a:p>
            <a:r>
              <a:rPr lang="en-US" sz="800" i="1" dirty="0"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Reprinted from The Lancet, Vol 399, Boden WE, </a:t>
            </a:r>
            <a:r>
              <a:rPr lang="en-US" sz="800" i="1" dirty="0" err="1"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Kaski</a:t>
            </a:r>
            <a:r>
              <a:rPr lang="en-US" sz="800" i="1" dirty="0"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 JC, Al-</a:t>
            </a:r>
            <a:r>
              <a:rPr lang="en-US" sz="800" i="1" dirty="0" err="1"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Lamee</a:t>
            </a:r>
            <a:r>
              <a:rPr lang="en-US" sz="800" i="1" dirty="0"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 R, Weintraub WS. What constitutes an appropriate empirical trial of antianginal therapy in patients with stable angina before referral for </a:t>
            </a:r>
            <a:r>
              <a:rPr lang="en-US" sz="800" i="1" dirty="0" err="1"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revascularisation</a:t>
            </a:r>
            <a:r>
              <a:rPr lang="en-US" sz="800" i="1" dirty="0">
                <a:effectLst/>
                <a:latin typeface="Georgia" panose="02040502050405020303" pitchFamily="18" charset="0"/>
                <a:ea typeface="Calibri" panose="020F0502020204030204" pitchFamily="34" charset="0"/>
                <a:cs typeface="Arial" panose="020B0604020202020204" pitchFamily="34" charset="0"/>
              </a:rPr>
              <a:t>?, Page 693, copyright (2022), with permission from Elsevier.</a:t>
            </a:r>
            <a:endParaRPr lang="en-GB" sz="800" dirty="0">
              <a:effectLst/>
              <a:latin typeface="Georgia" panose="02040502050405020303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 descr="Diagram&#10;&#10;Description automatically generated">
            <a:extLst>
              <a:ext uri="{FF2B5EF4-FFF2-40B4-BE49-F238E27FC236}">
                <a16:creationId xmlns:a16="http://schemas.microsoft.com/office/drawing/2014/main" id="{F1A85A66-AF21-45C3-BB8F-735D482E3BE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714" y="2667000"/>
            <a:ext cx="5984434" cy="3226888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400" b="1" dirty="0"/>
              <a:t>CONCLUSIONS &amp; FUTURE DIRECTIONS</a:t>
            </a:r>
            <a:endParaRPr lang="en-US" sz="24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4582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spcAft>
                <a:spcPts val="600"/>
              </a:spcAft>
              <a:buNone/>
            </a:pPr>
            <a:r>
              <a:rPr lang="en-US" altLang="en-US" sz="2000" dirty="0"/>
              <a:t>1 – Patients with INOCA remain a diagnostic and therapeutic challenge in clinical practice.</a:t>
            </a:r>
          </a:p>
          <a:p>
            <a:pPr marL="0" indent="0">
              <a:spcAft>
                <a:spcPts val="600"/>
              </a:spcAft>
              <a:buNone/>
            </a:pPr>
            <a:r>
              <a:rPr lang="en-US" altLang="en-US" sz="2000" dirty="0"/>
              <a:t>2 – There is growing evidence that phenotype-specific management improves patient outcomes.</a:t>
            </a:r>
          </a:p>
          <a:p>
            <a:pPr marL="0" indent="0">
              <a:spcAft>
                <a:spcPts val="600"/>
              </a:spcAft>
              <a:buNone/>
            </a:pPr>
            <a:r>
              <a:rPr lang="en-US" altLang="en-US" sz="2000" dirty="0"/>
              <a:t>3 – Treatment should be individualized and frequently reassessed, to achieve intensive control of cardiovascular risk factors and symptoms.</a:t>
            </a:r>
          </a:p>
          <a:p>
            <a:pPr marL="0" indent="0">
              <a:spcAft>
                <a:spcPts val="600"/>
              </a:spcAft>
              <a:buNone/>
            </a:pPr>
            <a:r>
              <a:rPr lang="en-US" altLang="en-US" sz="2000" dirty="0"/>
              <a:t>4 – The iCorMicA and WARRIOR trials are international studies investigating the benefit of phenotype-based management and guideline-directed optimal medical therapy.</a:t>
            </a:r>
          </a:p>
          <a:p>
            <a:pPr marL="0" indent="0">
              <a:spcAft>
                <a:spcPts val="600"/>
              </a:spcAft>
              <a:buNone/>
            </a:pPr>
            <a:r>
              <a:rPr lang="en-US" altLang="en-US" sz="2000" dirty="0"/>
              <a:t>5 – Coronary microvascular dysfunction-specific therapies under investigation include: </a:t>
            </a:r>
            <a:r>
              <a:rPr lang="en-US" altLang="en-US" sz="2000" dirty="0" err="1"/>
              <a:t>Zibotentan</a:t>
            </a:r>
            <a:r>
              <a:rPr lang="en-US" altLang="en-US" sz="2000" dirty="0"/>
              <a:t> (PRIZE study) and coronary sinus device therapies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2</TotalTime>
  <Words>695</Words>
  <Application>Microsoft Office PowerPoint</Application>
  <PresentationFormat>On-screen Show (4:3)</PresentationFormat>
  <Paragraphs>4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Arial</vt:lpstr>
      <vt:lpstr>Arial Narrow</vt:lpstr>
      <vt:lpstr>Calibri</vt:lpstr>
      <vt:lpstr>Georgia</vt:lpstr>
      <vt:lpstr>SsykbnAdvPTimes</vt:lpstr>
      <vt:lpstr>Times New Roman</vt:lpstr>
      <vt:lpstr>2_Office Theme</vt:lpstr>
      <vt:lpstr>Custom Design</vt:lpstr>
      <vt:lpstr>1_Custom Design</vt:lpstr>
      <vt:lpstr>Phenotype-based Management of Coronary Microvascular Dysfunction</vt:lpstr>
      <vt:lpstr>BACKGROUND</vt:lpstr>
      <vt:lpstr>Approach to Managing INOCA</vt:lpstr>
      <vt:lpstr>General Management Considerations</vt:lpstr>
      <vt:lpstr>Phenotype-specific Angina Therapy</vt:lpstr>
      <vt:lpstr>CONCLUSIONS &amp; FUTURE DIRECT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Daniel Ang</cp:lastModifiedBy>
  <cp:revision>119</cp:revision>
  <dcterms:created xsi:type="dcterms:W3CDTF">2011-04-18T21:44:13Z</dcterms:created>
  <dcterms:modified xsi:type="dcterms:W3CDTF">2022-04-12T13:30:33Z</dcterms:modified>
</cp:coreProperties>
</file>